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8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90678"/>
  </p:normalViewPr>
  <p:slideViewPr>
    <p:cSldViewPr snapToGrid="0" snapToObjects="1">
      <p:cViewPr varScale="1">
        <p:scale>
          <a:sx n="101" d="100"/>
          <a:sy n="101" d="100"/>
        </p:scale>
        <p:origin x="232" y="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Volumes/Appetite/Papers%20in%20progress/CompRev%20paper/fMRI%20Wanting%20and%20Restraint%20results%2015%20May%202019%20AP%20new%20color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4719828301297"/>
          <c:y val="9.5253526814227704E-2"/>
          <c:w val="0.774460480414631"/>
          <c:h val="0.637840788518457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ew May 2019 using 3 groups'!$T$63</c:f>
              <c:strCache>
                <c:ptCount val="1"/>
                <c:pt idx="0">
                  <c:v>Non-Stress</c:v>
                </c:pt>
              </c:strCache>
            </c:strRef>
          </c:tx>
          <c:spPr>
            <a:pattFill prst="dkUpDiag">
              <a:fgClr>
                <a:srgbClr val="FF6DF8"/>
              </a:fgClr>
              <a:bgClr>
                <a:schemeClr val="bg1"/>
              </a:bgClr>
            </a:patt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pattFill prst="dkUpDiag">
                <a:fgClr>
                  <a:srgbClr val="932092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1-C2E6-4E4B-AE98-9D158500A225}"/>
              </c:ext>
            </c:extLst>
          </c:dPt>
          <c:dPt>
            <c:idx val="1"/>
            <c:invertIfNegative val="0"/>
            <c:bubble3D val="0"/>
            <c:spPr>
              <a:pattFill prst="dkUpDiag">
                <a:fgClr>
                  <a:srgbClr val="932092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3-C2E6-4E4B-AE98-9D158500A225}"/>
              </c:ext>
            </c:extLst>
          </c:dPt>
          <c:dPt>
            <c:idx val="2"/>
            <c:invertIfNegative val="0"/>
            <c:bubble3D val="0"/>
            <c:spPr>
              <a:pattFill prst="dkUpDiag">
                <a:fgClr>
                  <a:srgbClr val="932092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5-C2E6-4E4B-AE98-9D158500A225}"/>
              </c:ext>
            </c:extLst>
          </c:dPt>
          <c:dPt>
            <c:idx val="3"/>
            <c:invertIfNegative val="0"/>
            <c:bubble3D val="0"/>
            <c:spPr>
              <a:pattFill prst="dkUpDiag">
                <a:fgClr>
                  <a:srgbClr val="FF40FF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7-C2E6-4E4B-AE98-9D158500A225}"/>
              </c:ext>
            </c:extLst>
          </c:dPt>
          <c:dPt>
            <c:idx val="4"/>
            <c:invertIfNegative val="0"/>
            <c:bubble3D val="0"/>
            <c:spPr>
              <a:pattFill prst="dkUpDiag">
                <a:fgClr>
                  <a:srgbClr val="FF40FF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9-C2E6-4E4B-AE98-9D158500A225}"/>
              </c:ext>
            </c:extLst>
          </c:dPt>
          <c:dPt>
            <c:idx val="5"/>
            <c:invertIfNegative val="0"/>
            <c:bubble3D val="0"/>
            <c:spPr>
              <a:pattFill prst="dkUpDiag">
                <a:fgClr>
                  <a:srgbClr val="FF40FF"/>
                </a:fgClr>
                <a:bgClr>
                  <a:schemeClr val="bg1"/>
                </a:bgClr>
              </a:patt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B-C2E6-4E4B-AE98-9D158500A225}"/>
              </c:ext>
            </c:extLst>
          </c:dPt>
          <c:errBars>
            <c:errBarType val="both"/>
            <c:errValType val="cust"/>
            <c:noEndCap val="0"/>
            <c:plus>
              <c:numRef>
                <c:f>'new May 2019 using 3 groups'!$AA$63:$AF$63</c:f>
                <c:numCache>
                  <c:formatCode>General</c:formatCode>
                  <c:ptCount val="6"/>
                  <c:pt idx="0">
                    <c:v>10.7668</c:v>
                  </c:pt>
                  <c:pt idx="1">
                    <c:v>8.1609200000000008</c:v>
                  </c:pt>
                  <c:pt idx="2">
                    <c:v>9.7492900000000002</c:v>
                  </c:pt>
                  <c:pt idx="3">
                    <c:v>4.99261</c:v>
                  </c:pt>
                  <c:pt idx="4">
                    <c:v>5.9392300000000002</c:v>
                  </c:pt>
                  <c:pt idx="5">
                    <c:v>7.2560500000000001</c:v>
                  </c:pt>
                </c:numCache>
              </c:numRef>
            </c:plus>
            <c:minus>
              <c:numRef>
                <c:f>'new May 2019 using 3 groups'!$AA$63:$AF$63</c:f>
                <c:numCache>
                  <c:formatCode>General</c:formatCode>
                  <c:ptCount val="6"/>
                  <c:pt idx="0">
                    <c:v>10.7668</c:v>
                  </c:pt>
                  <c:pt idx="1">
                    <c:v>8.1609200000000008</c:v>
                  </c:pt>
                  <c:pt idx="2">
                    <c:v>9.7492900000000002</c:v>
                  </c:pt>
                  <c:pt idx="3">
                    <c:v>4.99261</c:v>
                  </c:pt>
                  <c:pt idx="4">
                    <c:v>5.9392300000000002</c:v>
                  </c:pt>
                  <c:pt idx="5">
                    <c:v>7.25605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new May 2019 using 3 groups'!$U$61:$Z$62</c:f>
              <c:multiLvlStrCache>
                <c:ptCount val="6"/>
                <c:lvl>
                  <c:pt idx="0">
                    <c:v>High-ED food</c:v>
                  </c:pt>
                  <c:pt idx="1">
                    <c:v>Low-ED food</c:v>
                  </c:pt>
                  <c:pt idx="2">
                    <c:v>Non-food</c:v>
                  </c:pt>
                  <c:pt idx="3">
                    <c:v>High-ED food</c:v>
                  </c:pt>
                  <c:pt idx="4">
                    <c:v>Low-ED food</c:v>
                  </c:pt>
                  <c:pt idx="5">
                    <c:v>Non-food</c:v>
                  </c:pt>
                </c:lvl>
                <c:lvl>
                  <c:pt idx="0">
                    <c:v>Obese Binge Eating (n=6)</c:v>
                  </c:pt>
                  <c:pt idx="3">
                    <c:v>Obese Non-Binge Eating (n=11)</c:v>
                  </c:pt>
                </c:lvl>
              </c:multiLvlStrCache>
            </c:multiLvlStrRef>
          </c:cat>
          <c:val>
            <c:numRef>
              <c:f>'new May 2019 using 3 groups'!$U$63:$Z$63</c:f>
              <c:numCache>
                <c:formatCode>General</c:formatCode>
                <c:ptCount val="6"/>
                <c:pt idx="0">
                  <c:v>57.487699999999997</c:v>
                </c:pt>
                <c:pt idx="1">
                  <c:v>57.561900000000001</c:v>
                </c:pt>
                <c:pt idx="2">
                  <c:v>23.232199999999999</c:v>
                </c:pt>
                <c:pt idx="3">
                  <c:v>65.343100000000007</c:v>
                </c:pt>
                <c:pt idx="4">
                  <c:v>56.122600000000013</c:v>
                </c:pt>
                <c:pt idx="5">
                  <c:v>29.70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2E6-4E4B-AE98-9D158500A225}"/>
            </c:ext>
          </c:extLst>
        </c:ser>
        <c:ser>
          <c:idx val="1"/>
          <c:order val="1"/>
          <c:tx>
            <c:strRef>
              <c:f>'new May 2019 using 3 groups'!$T$64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rgbClr val="932092"/>
            </a:solidFill>
            <a:ln w="25400">
              <a:noFill/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FF40FF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E-C2E6-4E4B-AE98-9D158500A225}"/>
              </c:ext>
            </c:extLst>
          </c:dPt>
          <c:dPt>
            <c:idx val="4"/>
            <c:invertIfNegative val="0"/>
            <c:bubble3D val="0"/>
            <c:spPr>
              <a:solidFill>
                <a:srgbClr val="FF40FF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0-C2E6-4E4B-AE98-9D158500A225}"/>
              </c:ext>
            </c:extLst>
          </c:dPt>
          <c:dPt>
            <c:idx val="5"/>
            <c:invertIfNegative val="0"/>
            <c:bubble3D val="0"/>
            <c:spPr>
              <a:solidFill>
                <a:srgbClr val="FF40FF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2-C2E6-4E4B-AE98-9D158500A225}"/>
              </c:ext>
            </c:extLst>
          </c:dPt>
          <c:errBars>
            <c:errBarType val="both"/>
            <c:errValType val="cust"/>
            <c:noEndCap val="0"/>
            <c:plus>
              <c:numRef>
                <c:f>'new May 2019 using 3 groups'!$AA$64:$AF$64</c:f>
                <c:numCache>
                  <c:formatCode>General</c:formatCode>
                  <c:ptCount val="6"/>
                  <c:pt idx="0">
                    <c:v>9.74559</c:v>
                  </c:pt>
                  <c:pt idx="1">
                    <c:v>5.4366399999999997</c:v>
                  </c:pt>
                  <c:pt idx="2">
                    <c:v>6.3712</c:v>
                  </c:pt>
                  <c:pt idx="3">
                    <c:v>5.00122</c:v>
                  </c:pt>
                  <c:pt idx="4">
                    <c:v>6.61639</c:v>
                  </c:pt>
                  <c:pt idx="5">
                    <c:v>5.6962000000000002</c:v>
                  </c:pt>
                </c:numCache>
              </c:numRef>
            </c:plus>
            <c:minus>
              <c:numRef>
                <c:f>'new May 2019 using 3 groups'!$AA$64:$AF$64</c:f>
                <c:numCache>
                  <c:formatCode>General</c:formatCode>
                  <c:ptCount val="6"/>
                  <c:pt idx="0">
                    <c:v>9.74559</c:v>
                  </c:pt>
                  <c:pt idx="1">
                    <c:v>5.4366399999999997</c:v>
                  </c:pt>
                  <c:pt idx="2">
                    <c:v>6.3712</c:v>
                  </c:pt>
                  <c:pt idx="3">
                    <c:v>5.00122</c:v>
                  </c:pt>
                  <c:pt idx="4">
                    <c:v>6.61639</c:v>
                  </c:pt>
                  <c:pt idx="5">
                    <c:v>5.6962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new May 2019 using 3 groups'!$U$61:$Z$62</c:f>
              <c:multiLvlStrCache>
                <c:ptCount val="6"/>
                <c:lvl>
                  <c:pt idx="0">
                    <c:v>High-ED food</c:v>
                  </c:pt>
                  <c:pt idx="1">
                    <c:v>Low-ED food</c:v>
                  </c:pt>
                  <c:pt idx="2">
                    <c:v>Non-food</c:v>
                  </c:pt>
                  <c:pt idx="3">
                    <c:v>High-ED food</c:v>
                  </c:pt>
                  <c:pt idx="4">
                    <c:v>Low-ED food</c:v>
                  </c:pt>
                  <c:pt idx="5">
                    <c:v>Non-food</c:v>
                  </c:pt>
                </c:lvl>
                <c:lvl>
                  <c:pt idx="0">
                    <c:v>Obese Binge Eating (n=6)</c:v>
                  </c:pt>
                  <c:pt idx="3">
                    <c:v>Obese Non-Binge Eating (n=11)</c:v>
                  </c:pt>
                </c:lvl>
              </c:multiLvlStrCache>
            </c:multiLvlStrRef>
          </c:cat>
          <c:val>
            <c:numRef>
              <c:f>'new May 2019 using 3 groups'!$U$64:$Z$64</c:f>
              <c:numCache>
                <c:formatCode>General</c:formatCode>
                <c:ptCount val="6"/>
                <c:pt idx="0">
                  <c:v>57.635600000000011</c:v>
                </c:pt>
                <c:pt idx="1">
                  <c:v>65.600799999999978</c:v>
                </c:pt>
                <c:pt idx="2">
                  <c:v>31.535299999999999</c:v>
                </c:pt>
                <c:pt idx="3">
                  <c:v>58.211300000000001</c:v>
                </c:pt>
                <c:pt idx="4">
                  <c:v>49.142299999999999</c:v>
                </c:pt>
                <c:pt idx="5">
                  <c:v>28.09690000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C2E6-4E4B-AE98-9D158500A2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764176848"/>
        <c:axId val="-1764175072"/>
      </c:barChart>
      <c:catAx>
        <c:axId val="-1764176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1764175072"/>
        <c:crosses val="autoZero"/>
        <c:auto val="1"/>
        <c:lblAlgn val="ctr"/>
        <c:lblOffset val="100"/>
        <c:tickLblSkip val="1"/>
        <c:noMultiLvlLbl val="0"/>
      </c:catAx>
      <c:valAx>
        <c:axId val="-1764175072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Wanting scores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1764176848"/>
        <c:crossesAt val="1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6415</cdr:x>
      <cdr:y>0.05213</cdr:y>
    </cdr:from>
    <cdr:to>
      <cdr:x>0.98772</cdr:x>
      <cdr:y>0.15486</cdr:y>
    </cdr:to>
    <cdr:grpSp>
      <cdr:nvGrpSpPr>
        <cdr:cNvPr id="9" name="Group 8">
          <a:extLst xmlns:a="http://schemas.openxmlformats.org/drawingml/2006/main">
            <a:ext uri="{FF2B5EF4-FFF2-40B4-BE49-F238E27FC236}">
              <a16:creationId xmlns:a16="http://schemas.microsoft.com/office/drawing/2014/main" id="{57379B53-27B1-824F-8271-1F0D9DF1265A}"/>
            </a:ext>
          </a:extLst>
        </cdr:cNvPr>
        <cdr:cNvGrpSpPr/>
      </cdr:nvGrpSpPr>
      <cdr:grpSpPr>
        <a:xfrm xmlns:a="http://schemas.openxmlformats.org/drawingml/2006/main">
          <a:off x="4308889" y="200932"/>
          <a:ext cx="1260667" cy="395968"/>
          <a:chOff x="0" y="0"/>
          <a:chExt cx="1260631" cy="395975"/>
        </a:xfrm>
      </cdr:grpSpPr>
      <cdr:pic>
        <cdr:nvPicPr>
          <cdr:cNvPr id="10" name="Picture 9">
            <a:extLst xmlns:a="http://schemas.openxmlformats.org/drawingml/2006/main">
              <a:ext uri="{FF2B5EF4-FFF2-40B4-BE49-F238E27FC236}">
                <a16:creationId xmlns:a16="http://schemas.microsoft.com/office/drawing/2014/main" id="{2CD66BFF-C658-E943-BE22-2742A7312370}"/>
              </a:ext>
            </a:extLst>
          </cdr:cNvPr>
          <cdr:cNvPicPr/>
        </cdr:nvPicPr>
        <cdr:blipFill rotWithShape="1">
          <a:blip xmlns:a="http://schemas.openxmlformats.org/drawingml/2006/main"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xmlns:a="http://schemas.openxmlformats.org/drawingml/2006/main" l="39191"/>
          <a:stretch xmlns:a="http://schemas.openxmlformats.org/drawingml/2006/main"/>
        </cdr:blipFill>
        <cdr:spPr>
          <a:xfrm xmlns:a="http://schemas.openxmlformats.org/drawingml/2006/main">
            <a:off x="476246" y="4141"/>
            <a:ext cx="784385" cy="391834"/>
          </a:xfrm>
          <a:prstGeom xmlns:a="http://schemas.openxmlformats.org/drawingml/2006/main" prst="rect">
            <a:avLst/>
          </a:prstGeom>
        </cdr:spPr>
      </cdr:pic>
      <cdr:pic>
        <cdr:nvPicPr>
          <cdr:cNvPr id="11" name="Picture 10">
            <a:extLst xmlns:a="http://schemas.openxmlformats.org/drawingml/2006/main">
              <a:ext uri="{FF2B5EF4-FFF2-40B4-BE49-F238E27FC236}">
                <a16:creationId xmlns:a16="http://schemas.microsoft.com/office/drawing/2014/main" id="{682C514E-56A2-3D48-ADB7-A1F8CD4A7305}"/>
              </a:ext>
            </a:extLst>
          </cdr:cNvPr>
          <cdr:cNvPicPr/>
        </cdr:nvPicPr>
        <cdr:blipFill>
          <a:blip xmlns:a="http://schemas.openxmlformats.org/drawingml/2006/main" xmlns:r="http://schemas.openxmlformats.org/officeDocument/2006/relationships" r:embed="rId2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975" y="260138"/>
            <a:ext cx="135837" cy="135837"/>
          </a:xfrm>
          <a:prstGeom xmlns:a="http://schemas.openxmlformats.org/drawingml/2006/main" prst="rect">
            <a:avLst/>
          </a:prstGeom>
        </cdr:spPr>
      </cdr:pic>
      <cdr:pic>
        <cdr:nvPicPr>
          <cdr:cNvPr id="12" name="Picture 11">
            <a:extLst xmlns:a="http://schemas.openxmlformats.org/drawingml/2006/main">
              <a:ext uri="{FF2B5EF4-FFF2-40B4-BE49-F238E27FC236}">
                <a16:creationId xmlns:a16="http://schemas.microsoft.com/office/drawing/2014/main" id="{4A4AD746-2ECA-734A-8F1E-7963A7BC1A30}"/>
              </a:ext>
            </a:extLst>
          </cdr:cNvPr>
          <cdr:cNvPicPr/>
        </cdr:nvPicPr>
        <cdr:blipFill>
          <a:blip xmlns:a="http://schemas.openxmlformats.org/drawingml/2006/main" xmlns:r="http://schemas.openxmlformats.org/officeDocument/2006/relationships" r:embed="rId3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234386" y="0"/>
            <a:ext cx="142337" cy="134429"/>
          </a:xfrm>
          <a:prstGeom xmlns:a="http://schemas.openxmlformats.org/drawingml/2006/main" prst="rect">
            <a:avLst/>
          </a:prstGeom>
        </cdr:spPr>
      </cdr:pic>
      <cdr:pic>
        <cdr:nvPicPr>
          <cdr:cNvPr id="13" name="Picture 12">
            <a:extLst xmlns:a="http://schemas.openxmlformats.org/drawingml/2006/main">
              <a:ext uri="{FF2B5EF4-FFF2-40B4-BE49-F238E27FC236}">
                <a16:creationId xmlns:a16="http://schemas.microsoft.com/office/drawing/2014/main" id="{7BEE378F-3AA3-4343-BF60-53FDB9CD5F71}"/>
              </a:ext>
            </a:extLst>
          </cdr:cNvPr>
          <cdr:cNvPicPr/>
        </cdr:nvPicPr>
        <cdr:blipFill>
          <a:blip xmlns:a="http://schemas.openxmlformats.org/drawingml/2006/main" xmlns:r="http://schemas.openxmlformats.org/officeDocument/2006/relationships" r:embed="rId4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240886" y="258110"/>
            <a:ext cx="135837" cy="137865"/>
          </a:xfrm>
          <a:prstGeom xmlns:a="http://schemas.openxmlformats.org/drawingml/2006/main" prst="rect">
            <a:avLst/>
          </a:prstGeom>
        </cdr:spPr>
      </cdr:pic>
      <cdr:pic>
        <cdr:nvPicPr>
          <cdr:cNvPr id="14" name="Picture 13">
            <a:extLst xmlns:a="http://schemas.openxmlformats.org/drawingml/2006/main">
              <a:ext uri="{FF2B5EF4-FFF2-40B4-BE49-F238E27FC236}">
                <a16:creationId xmlns:a16="http://schemas.microsoft.com/office/drawing/2014/main" id="{5C82C145-3F46-6046-9353-1C584136ABDE}"/>
              </a:ext>
            </a:extLst>
          </cdr:cNvPr>
          <cdr:cNvPicPr>
            <a:picLocks xmlns:a="http://schemas.openxmlformats.org/drawingml/2006/main" noChangeAspect="1"/>
          </cdr:cNvPicPr>
        </cdr:nvPicPr>
        <cdr:blipFill>
          <a:blip xmlns:a="http://schemas.openxmlformats.org/drawingml/2006/main" xmlns:r="http://schemas.openxmlformats.org/officeDocument/2006/relationships" r:embed="rId5"/>
          <a:stretch xmlns:a="http://schemas.openxmlformats.org/drawingml/2006/main">
            <a:fillRect/>
          </a:stretch>
        </cdr:blipFill>
        <cdr:spPr>
          <a:xfrm xmlns:a="http://schemas.openxmlformats.org/drawingml/2006/main">
            <a:off x="0" y="4141"/>
            <a:ext cx="135837" cy="137865"/>
          </a:xfrm>
          <a:prstGeom xmlns:a="http://schemas.openxmlformats.org/drawingml/2006/main" prst="rect">
            <a:avLst/>
          </a:prstGeom>
        </cdr:spPr>
      </cdr:pic>
    </cdr:grp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E0BD0D-D87C-E041-9F0E-E8A11D85390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2F4DFD-4BD3-3E41-8C40-564BD95A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438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upplementary Fig 6: Wanting scores for each cue type by binge eating sub-group and conditio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F0FE14C-31E7-4846-8655-2F062EBFACAF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3760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A3834-C101-3945-B19D-69673FCA2B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41B029-85A3-0244-8698-9213CCAE64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3F7F54-B40F-4E44-A2CA-6C1C415F1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BC87C9-BCFD-0C46-8409-2DD9546EC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C040E-F8EE-C24B-98BF-1C89D1408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159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06462-6A2B-9840-BE9F-18E9446915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2EE7B-BF38-4F47-8755-3D43AB9038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272F08-D02A-4B4A-8DFB-DB4DC4161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38C695-105E-984C-B68B-82DCAE080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224BFB-6BD0-A948-B416-3E20D7F5B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083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7D1DCA-0005-AE42-BBF1-65987ED558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BCEE5E-1C44-F24C-A1CA-5E0E567B5D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D908C1-A229-5E4D-A0BC-E42C7BB19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E15B1F-4548-DE4C-BC39-83B1EE413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8B0EEE-9202-5240-84E2-A1574B472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327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15C19-2D4D-8E42-A0B6-E8E7AEB63D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CCD456-5F5D-7742-8495-FFD644182C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880D7-6744-0F4D-A371-B61C7827B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0A87EA-5368-9A41-993D-B507BF876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6C5822-9F31-2D41-BE46-FEAE01406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301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C9B60-EC54-E84A-AD8D-220A03D1A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47D6D-9229-D44F-AEDA-44309D0F0C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A1BAE1-2A29-BB4D-8B75-F56E399DB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BEB49-10D1-124C-BC33-21FCC2DCF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F37DBC-D4C1-9849-B57C-27A922893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44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B8E79-2EE5-2A40-83D9-6CE100B0B5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3C01CC-5FB8-5C43-9C54-2F6BA6907B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89D0BC-67B6-4746-A564-7F877AACF3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83FFC8-1392-464B-BDC5-E68D42FE9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062723-DF64-6543-9F56-C01A27DB2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EC73E2-2C84-C349-81A7-AEE1DB5E8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258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A41A6B-C2BE-0E4F-A5AE-14A64BE0A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71B620-B6C9-8541-A78B-28608BC273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D6B784-B5A2-1043-85D5-0C44817C77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3E58C9-BF80-4847-AAF5-6CDBD79FE0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93E518-FBF0-8049-A35A-1CFCF3BADC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BA8262-B642-0D45-870A-C738D4E4A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A76BD2-DF76-554C-8965-2667BC300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4C1C77-8BFF-5146-841F-741C3E295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436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72A27-9843-044F-A868-45618123CB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7DBFA7-FB1C-3343-9C98-8FA945C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8214C0-16A8-6740-92D6-2677FDA60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8F1336-04B9-FE45-BD23-FE46DC941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967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40D961-391F-384F-8FDB-FB9902B73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6C80F7-7CAB-644B-B1F7-FFE461CF3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9914FE-39EC-854B-8AD0-74440A424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282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9B312-5D52-8A45-A445-7DC71EAB83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2870E7-4645-0F4C-BF86-BCBC012247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D01CB4-FA01-4246-B37E-EFC9827E51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D020F5-7CE0-4B4E-A3D0-C29111E72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78FAE5-1832-C84C-B7A0-FBE859A3B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8E6552-C97A-9C47-B050-36EAD5878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384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84C99-4DEB-E448-A23C-258F1B9D3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D07039-9535-9D45-AE45-05C8AFE39A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93BCA0-9284-7645-BDE9-7F2EFC0CE2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1D0D69-FCE8-F84E-9953-C7FC4E2D7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6DF05C-A138-2B40-BAE8-091E92456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FF825E-8BA2-9146-8B4C-1F633E6A2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879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D94876-5228-B546-9354-F52EFE230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559FAD-1062-DB4C-A508-E4CE6744FA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4A63CC-8CE2-B342-91CF-DB33E1829D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3388F-E0DA-5B4C-978F-0E85E9DE9E9A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1844CC-3AC2-4147-AB5D-DB2A3F824F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BF27E-0E73-F14E-8BA4-25EA939DC2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CA1AB-C38A-8E4F-BC81-B31F9CFDC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029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E693D56-7B3B-C14E-BAC8-CB518BB0C10E}"/>
              </a:ext>
            </a:extLst>
          </p:cNvPr>
          <p:cNvGraphicFramePr/>
          <p:nvPr/>
        </p:nvGraphicFramePr>
        <p:xfrm>
          <a:off x="3276600" y="1501775"/>
          <a:ext cx="5638800" cy="3854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69088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3</cp:revision>
  <dcterms:created xsi:type="dcterms:W3CDTF">2021-05-24T12:55:15Z</dcterms:created>
  <dcterms:modified xsi:type="dcterms:W3CDTF">2022-08-31T20:44:43Z</dcterms:modified>
</cp:coreProperties>
</file>